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s-ES_trad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4" d="100"/>
          <a:sy n="104" d="100"/>
        </p:scale>
        <p:origin x="-387" y="-21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F64685-93FE-4D86-A185-28F1F9B5BD4E}" type="datetimeFigureOut">
              <a:rPr lang="es-ES_tradnl" smtClean="0"/>
              <a:t>09/05/2011</a:t>
            </a:fld>
            <a:endParaRPr lang="es-ES_tradn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9FC5DD-BBD0-4CA8-BA29-9C1A726D406C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28892561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C9FC5DD-BBD0-4CA8-BA29-9C1A726D406C}" type="slidenum">
              <a:rPr lang="es-ES_tradnl" smtClean="0"/>
              <a:t>1</a:t>
            </a:fld>
            <a:endParaRPr lang="es-ES_tradnl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C7B56-E4DA-4BDD-B54B-E3FA7DF37A62}" type="datetimeFigureOut">
              <a:rPr lang="es-ES_tradnl" smtClean="0"/>
              <a:t>09/05/2011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585E-C405-4458-B893-0FDB457252D8}" type="slidenum">
              <a:rPr lang="es-ES_tradnl" smtClean="0"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C7B56-E4DA-4BDD-B54B-E3FA7DF37A62}" type="datetimeFigureOut">
              <a:rPr lang="es-ES_tradnl" smtClean="0"/>
              <a:t>09/05/2011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585E-C405-4458-B893-0FDB457252D8}" type="slidenum">
              <a:rPr lang="es-ES_tradnl" smtClean="0"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C7B56-E4DA-4BDD-B54B-E3FA7DF37A62}" type="datetimeFigureOut">
              <a:rPr lang="es-ES_tradnl" smtClean="0"/>
              <a:t>09/05/2011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585E-C405-4458-B893-0FDB457252D8}" type="slidenum">
              <a:rPr lang="es-ES_tradnl" smtClean="0"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C7B56-E4DA-4BDD-B54B-E3FA7DF37A62}" type="datetimeFigureOut">
              <a:rPr lang="es-ES_tradnl" smtClean="0"/>
              <a:t>09/05/2011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585E-C405-4458-B893-0FDB457252D8}" type="slidenum">
              <a:rPr lang="es-ES_tradnl" smtClean="0"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C7B56-E4DA-4BDD-B54B-E3FA7DF37A62}" type="datetimeFigureOut">
              <a:rPr lang="es-ES_tradnl" smtClean="0"/>
              <a:t>09/05/2011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585E-C405-4458-B893-0FDB457252D8}" type="slidenum">
              <a:rPr lang="es-ES_tradnl" smtClean="0"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C7B56-E4DA-4BDD-B54B-E3FA7DF37A62}" type="datetimeFigureOut">
              <a:rPr lang="es-ES_tradnl" smtClean="0"/>
              <a:t>09/05/2011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585E-C405-4458-B893-0FDB457252D8}" type="slidenum">
              <a:rPr lang="es-ES_tradnl" smtClean="0"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C7B56-E4DA-4BDD-B54B-E3FA7DF37A62}" type="datetimeFigureOut">
              <a:rPr lang="es-ES_tradnl" smtClean="0"/>
              <a:t>09/05/2011</a:t>
            </a:fld>
            <a:endParaRPr lang="es-ES_trad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585E-C405-4458-B893-0FDB457252D8}" type="slidenum">
              <a:rPr lang="es-ES_tradnl" smtClean="0"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C7B56-E4DA-4BDD-B54B-E3FA7DF37A62}" type="datetimeFigureOut">
              <a:rPr lang="es-ES_tradnl" smtClean="0"/>
              <a:t>09/05/2011</a:t>
            </a:fld>
            <a:endParaRPr lang="es-ES_trad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585E-C405-4458-B893-0FDB457252D8}" type="slidenum">
              <a:rPr lang="es-ES_tradnl" smtClean="0"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C7B56-E4DA-4BDD-B54B-E3FA7DF37A62}" type="datetimeFigureOut">
              <a:rPr lang="es-ES_tradnl" smtClean="0"/>
              <a:t>09/05/2011</a:t>
            </a:fld>
            <a:endParaRPr lang="es-ES_trad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585E-C405-4458-B893-0FDB457252D8}" type="slidenum">
              <a:rPr lang="es-ES_tradnl" smtClean="0"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C7B56-E4DA-4BDD-B54B-E3FA7DF37A62}" type="datetimeFigureOut">
              <a:rPr lang="es-ES_tradnl" smtClean="0"/>
              <a:t>09/05/2011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585E-C405-4458-B893-0FDB457252D8}" type="slidenum">
              <a:rPr lang="es-ES_tradnl" smtClean="0"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_tradn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C7B56-E4DA-4BDD-B54B-E3FA7DF37A62}" type="datetimeFigureOut">
              <a:rPr lang="es-ES_tradnl" smtClean="0"/>
              <a:t>09/05/2011</a:t>
            </a:fld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5585E-C405-4458-B893-0FDB457252D8}" type="slidenum">
              <a:rPr lang="es-ES_tradnl" smtClean="0"/>
              <a:t>‹#›</a:t>
            </a:fld>
            <a:endParaRPr lang="es-ES_trad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C7B56-E4DA-4BDD-B54B-E3FA7DF37A62}" type="datetimeFigureOut">
              <a:rPr lang="es-ES_tradnl" smtClean="0"/>
              <a:t>09/05/2011</a:t>
            </a:fld>
            <a:endParaRPr lang="es-ES_trad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A5585E-C405-4458-B893-0FDB457252D8}" type="slidenum">
              <a:rPr lang="es-ES_tradnl" smtClean="0"/>
              <a:t>‹#›</a:t>
            </a:fld>
            <a:endParaRPr lang="es-ES_trad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533400" y="1106875"/>
            <a:ext cx="5610225" cy="201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9" name="TextBox 3"/>
          <p:cNvSpPr txBox="1">
            <a:spLocks noChangeArrowheads="1"/>
          </p:cNvSpPr>
          <p:nvPr/>
        </p:nvSpPr>
        <p:spPr bwMode="auto">
          <a:xfrm>
            <a:off x="457200" y="609600"/>
            <a:ext cx="5791200" cy="46166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200" b="1" dirty="0">
                <a:latin typeface="Calibri" pitchFamily="34" charset="0"/>
              </a:rPr>
              <a:t>Supplementary Table </a:t>
            </a:r>
            <a:r>
              <a:rPr lang="en-US" sz="1200" b="1" dirty="0" smtClean="0">
                <a:latin typeface="Calibri" pitchFamily="34" charset="0"/>
              </a:rPr>
              <a:t>S9.  Gene expression commonalities with other array studies in HIV human brain tissue. </a:t>
            </a:r>
            <a:endParaRPr lang="en-US" sz="1200" dirty="0"/>
          </a:p>
        </p:txBody>
      </p:sp>
      <p:sp>
        <p:nvSpPr>
          <p:cNvPr id="2" name="Freeform 1"/>
          <p:cNvSpPr/>
          <p:nvPr/>
        </p:nvSpPr>
        <p:spPr>
          <a:xfrm>
            <a:off x="1243263" y="786063"/>
            <a:ext cx="786063" cy="721895"/>
          </a:xfrm>
          <a:custGeom>
            <a:avLst/>
            <a:gdLst>
              <a:gd name="connsiteX0" fmla="*/ 401053 w 786063"/>
              <a:gd name="connsiteY0" fmla="*/ 224590 h 721895"/>
              <a:gd name="connsiteX1" fmla="*/ 352926 w 786063"/>
              <a:gd name="connsiteY1" fmla="*/ 192505 h 721895"/>
              <a:gd name="connsiteX2" fmla="*/ 320842 w 786063"/>
              <a:gd name="connsiteY2" fmla="*/ 160421 h 721895"/>
              <a:gd name="connsiteX3" fmla="*/ 288758 w 786063"/>
              <a:gd name="connsiteY3" fmla="*/ 176463 h 721895"/>
              <a:gd name="connsiteX4" fmla="*/ 272716 w 786063"/>
              <a:gd name="connsiteY4" fmla="*/ 208548 h 721895"/>
              <a:gd name="connsiteX5" fmla="*/ 208548 w 786063"/>
              <a:gd name="connsiteY5" fmla="*/ 240632 h 721895"/>
              <a:gd name="connsiteX6" fmla="*/ 192505 w 786063"/>
              <a:gd name="connsiteY6" fmla="*/ 256674 h 721895"/>
              <a:gd name="connsiteX7" fmla="*/ 144379 w 786063"/>
              <a:gd name="connsiteY7" fmla="*/ 304800 h 721895"/>
              <a:gd name="connsiteX8" fmla="*/ 128337 w 786063"/>
              <a:gd name="connsiteY8" fmla="*/ 336884 h 721895"/>
              <a:gd name="connsiteX9" fmla="*/ 96253 w 786063"/>
              <a:gd name="connsiteY9" fmla="*/ 368969 h 721895"/>
              <a:gd name="connsiteX10" fmla="*/ 48126 w 786063"/>
              <a:gd name="connsiteY10" fmla="*/ 417095 h 721895"/>
              <a:gd name="connsiteX11" fmla="*/ 16042 w 786063"/>
              <a:gd name="connsiteY11" fmla="*/ 481263 h 721895"/>
              <a:gd name="connsiteX12" fmla="*/ 0 w 786063"/>
              <a:gd name="connsiteY12" fmla="*/ 513348 h 721895"/>
              <a:gd name="connsiteX13" fmla="*/ 48126 w 786063"/>
              <a:gd name="connsiteY13" fmla="*/ 673769 h 721895"/>
              <a:gd name="connsiteX14" fmla="*/ 64169 w 786063"/>
              <a:gd name="connsiteY14" fmla="*/ 689811 h 721895"/>
              <a:gd name="connsiteX15" fmla="*/ 128337 w 786063"/>
              <a:gd name="connsiteY15" fmla="*/ 721895 h 721895"/>
              <a:gd name="connsiteX16" fmla="*/ 449179 w 786063"/>
              <a:gd name="connsiteY16" fmla="*/ 705853 h 721895"/>
              <a:gd name="connsiteX17" fmla="*/ 481263 w 786063"/>
              <a:gd name="connsiteY17" fmla="*/ 689811 h 721895"/>
              <a:gd name="connsiteX18" fmla="*/ 609600 w 786063"/>
              <a:gd name="connsiteY18" fmla="*/ 657726 h 721895"/>
              <a:gd name="connsiteX19" fmla="*/ 641684 w 786063"/>
              <a:gd name="connsiteY19" fmla="*/ 641684 h 721895"/>
              <a:gd name="connsiteX20" fmla="*/ 657726 w 786063"/>
              <a:gd name="connsiteY20" fmla="*/ 609600 h 721895"/>
              <a:gd name="connsiteX21" fmla="*/ 673769 w 786063"/>
              <a:gd name="connsiteY21" fmla="*/ 593558 h 721895"/>
              <a:gd name="connsiteX22" fmla="*/ 705853 w 786063"/>
              <a:gd name="connsiteY22" fmla="*/ 529390 h 721895"/>
              <a:gd name="connsiteX23" fmla="*/ 721895 w 786063"/>
              <a:gd name="connsiteY23" fmla="*/ 497305 h 721895"/>
              <a:gd name="connsiteX24" fmla="*/ 737937 w 786063"/>
              <a:gd name="connsiteY24" fmla="*/ 417095 h 721895"/>
              <a:gd name="connsiteX25" fmla="*/ 786063 w 786063"/>
              <a:gd name="connsiteY25" fmla="*/ 240632 h 721895"/>
              <a:gd name="connsiteX26" fmla="*/ 753979 w 786063"/>
              <a:gd name="connsiteY26" fmla="*/ 80211 h 721895"/>
              <a:gd name="connsiteX27" fmla="*/ 737937 w 786063"/>
              <a:gd name="connsiteY27" fmla="*/ 48126 h 721895"/>
              <a:gd name="connsiteX28" fmla="*/ 673769 w 786063"/>
              <a:gd name="connsiteY28" fmla="*/ 16042 h 721895"/>
              <a:gd name="connsiteX29" fmla="*/ 657726 w 786063"/>
              <a:gd name="connsiteY29" fmla="*/ 0 h 721895"/>
              <a:gd name="connsiteX30" fmla="*/ 417095 w 786063"/>
              <a:gd name="connsiteY30" fmla="*/ 48126 h 721895"/>
              <a:gd name="connsiteX31" fmla="*/ 336884 w 786063"/>
              <a:gd name="connsiteY31" fmla="*/ 64169 h 721895"/>
              <a:gd name="connsiteX32" fmla="*/ 224590 w 786063"/>
              <a:gd name="connsiteY32" fmla="*/ 112295 h 721895"/>
              <a:gd name="connsiteX33" fmla="*/ 192505 w 786063"/>
              <a:gd name="connsiteY33" fmla="*/ 128337 h 721895"/>
              <a:gd name="connsiteX34" fmla="*/ 160421 w 786063"/>
              <a:gd name="connsiteY34" fmla="*/ 144379 h 721895"/>
              <a:gd name="connsiteX35" fmla="*/ 128337 w 786063"/>
              <a:gd name="connsiteY35" fmla="*/ 208548 h 721895"/>
              <a:gd name="connsiteX36" fmla="*/ 96253 w 786063"/>
              <a:gd name="connsiteY36" fmla="*/ 224590 h 721895"/>
              <a:gd name="connsiteX37" fmla="*/ 96253 w 786063"/>
              <a:gd name="connsiteY37" fmla="*/ 256674 h 72189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</a:cxnLst>
            <a:rect l="l" t="t" r="r" b="b"/>
            <a:pathLst>
              <a:path w="786063" h="721895">
                <a:moveTo>
                  <a:pt x="401053" y="224590"/>
                </a:moveTo>
                <a:cubicBezTo>
                  <a:pt x="385011" y="213895"/>
                  <a:pt x="367982" y="204549"/>
                  <a:pt x="352926" y="192505"/>
                </a:cubicBezTo>
                <a:cubicBezTo>
                  <a:pt x="341116" y="183057"/>
                  <a:pt x="335515" y="164089"/>
                  <a:pt x="320842" y="160421"/>
                </a:cubicBezTo>
                <a:cubicBezTo>
                  <a:pt x="309242" y="157521"/>
                  <a:pt x="299453" y="171116"/>
                  <a:pt x="288758" y="176463"/>
                </a:cubicBezTo>
                <a:cubicBezTo>
                  <a:pt x="283411" y="187158"/>
                  <a:pt x="282053" y="201078"/>
                  <a:pt x="272716" y="208548"/>
                </a:cubicBezTo>
                <a:cubicBezTo>
                  <a:pt x="254042" y="223487"/>
                  <a:pt x="225458" y="223723"/>
                  <a:pt x="208548" y="240632"/>
                </a:cubicBezTo>
                <a:lnTo>
                  <a:pt x="192505" y="256674"/>
                </a:lnTo>
                <a:cubicBezTo>
                  <a:pt x="149726" y="342231"/>
                  <a:pt x="208547" y="240632"/>
                  <a:pt x="144379" y="304800"/>
                </a:cubicBezTo>
                <a:cubicBezTo>
                  <a:pt x="135924" y="313255"/>
                  <a:pt x="135511" y="327318"/>
                  <a:pt x="128337" y="336884"/>
                </a:cubicBezTo>
                <a:cubicBezTo>
                  <a:pt x="119262" y="348984"/>
                  <a:pt x="105328" y="356869"/>
                  <a:pt x="96253" y="368969"/>
                </a:cubicBezTo>
                <a:cubicBezTo>
                  <a:pt x="57753" y="420303"/>
                  <a:pt x="108016" y="387151"/>
                  <a:pt x="48126" y="417095"/>
                </a:cubicBezTo>
                <a:lnTo>
                  <a:pt x="16042" y="481263"/>
                </a:lnTo>
                <a:lnTo>
                  <a:pt x="0" y="513348"/>
                </a:lnTo>
                <a:cubicBezTo>
                  <a:pt x="7288" y="557075"/>
                  <a:pt x="10823" y="636468"/>
                  <a:pt x="48126" y="673769"/>
                </a:cubicBezTo>
                <a:cubicBezTo>
                  <a:pt x="53474" y="679116"/>
                  <a:pt x="57684" y="685920"/>
                  <a:pt x="64169" y="689811"/>
                </a:cubicBezTo>
                <a:cubicBezTo>
                  <a:pt x="84675" y="702115"/>
                  <a:pt x="128337" y="721895"/>
                  <a:pt x="128337" y="721895"/>
                </a:cubicBezTo>
                <a:cubicBezTo>
                  <a:pt x="235284" y="716548"/>
                  <a:pt x="342538" y="715548"/>
                  <a:pt x="449179" y="705853"/>
                </a:cubicBezTo>
                <a:cubicBezTo>
                  <a:pt x="461087" y="704770"/>
                  <a:pt x="470161" y="694252"/>
                  <a:pt x="481263" y="689811"/>
                </a:cubicBezTo>
                <a:cubicBezTo>
                  <a:pt x="530590" y="670081"/>
                  <a:pt x="552583" y="669130"/>
                  <a:pt x="609600" y="657726"/>
                </a:cubicBezTo>
                <a:cubicBezTo>
                  <a:pt x="620295" y="652379"/>
                  <a:pt x="633229" y="650139"/>
                  <a:pt x="641684" y="641684"/>
                </a:cubicBezTo>
                <a:cubicBezTo>
                  <a:pt x="650139" y="633229"/>
                  <a:pt x="651093" y="619549"/>
                  <a:pt x="657726" y="609600"/>
                </a:cubicBezTo>
                <a:cubicBezTo>
                  <a:pt x="661921" y="603308"/>
                  <a:pt x="668421" y="598905"/>
                  <a:pt x="673769" y="593558"/>
                </a:cubicBezTo>
                <a:lnTo>
                  <a:pt x="705853" y="529390"/>
                </a:lnTo>
                <a:lnTo>
                  <a:pt x="721895" y="497305"/>
                </a:lnTo>
                <a:cubicBezTo>
                  <a:pt x="727242" y="470568"/>
                  <a:pt x="730763" y="443400"/>
                  <a:pt x="737937" y="417095"/>
                </a:cubicBezTo>
                <a:cubicBezTo>
                  <a:pt x="798996" y="193209"/>
                  <a:pt x="746979" y="436050"/>
                  <a:pt x="786063" y="240632"/>
                </a:cubicBezTo>
                <a:cubicBezTo>
                  <a:pt x="774586" y="160290"/>
                  <a:pt x="778867" y="142433"/>
                  <a:pt x="753979" y="80211"/>
                </a:cubicBezTo>
                <a:cubicBezTo>
                  <a:pt x="749538" y="69109"/>
                  <a:pt x="747274" y="55596"/>
                  <a:pt x="737937" y="48126"/>
                </a:cubicBezTo>
                <a:cubicBezTo>
                  <a:pt x="719263" y="33187"/>
                  <a:pt x="690679" y="32951"/>
                  <a:pt x="673769" y="16042"/>
                </a:cubicBezTo>
                <a:lnTo>
                  <a:pt x="657726" y="0"/>
                </a:lnTo>
                <a:cubicBezTo>
                  <a:pt x="378017" y="39958"/>
                  <a:pt x="726447" y="-13747"/>
                  <a:pt x="417095" y="48126"/>
                </a:cubicBezTo>
                <a:cubicBezTo>
                  <a:pt x="390358" y="53474"/>
                  <a:pt x="363336" y="57556"/>
                  <a:pt x="336884" y="64169"/>
                </a:cubicBezTo>
                <a:cubicBezTo>
                  <a:pt x="289674" y="75972"/>
                  <a:pt x="270504" y="89338"/>
                  <a:pt x="224590" y="112295"/>
                </a:cubicBezTo>
                <a:lnTo>
                  <a:pt x="192505" y="128337"/>
                </a:lnTo>
                <a:lnTo>
                  <a:pt x="160421" y="144379"/>
                </a:lnTo>
                <a:cubicBezTo>
                  <a:pt x="149726" y="165769"/>
                  <a:pt x="149727" y="197853"/>
                  <a:pt x="128337" y="208548"/>
                </a:cubicBezTo>
                <a:cubicBezTo>
                  <a:pt x="117642" y="213895"/>
                  <a:pt x="102886" y="214641"/>
                  <a:pt x="96253" y="224590"/>
                </a:cubicBezTo>
                <a:cubicBezTo>
                  <a:pt x="90321" y="233489"/>
                  <a:pt x="96253" y="245979"/>
                  <a:pt x="96253" y="256674"/>
                </a:cubicBezTo>
              </a:path>
            </a:pathLst>
          </a:cu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Freeform 2"/>
          <p:cNvSpPr/>
          <p:nvPr/>
        </p:nvSpPr>
        <p:spPr>
          <a:xfrm>
            <a:off x="5734388" y="914400"/>
            <a:ext cx="707982" cy="641684"/>
          </a:xfrm>
          <a:custGeom>
            <a:avLst/>
            <a:gdLst>
              <a:gd name="connsiteX0" fmla="*/ 401717 w 707982"/>
              <a:gd name="connsiteY0" fmla="*/ 48126 h 641684"/>
              <a:gd name="connsiteX1" fmla="*/ 353591 w 707982"/>
              <a:gd name="connsiteY1" fmla="*/ 16042 h 641684"/>
              <a:gd name="connsiteX2" fmla="*/ 321507 w 707982"/>
              <a:gd name="connsiteY2" fmla="*/ 0 h 641684"/>
              <a:gd name="connsiteX3" fmla="*/ 129001 w 707982"/>
              <a:gd name="connsiteY3" fmla="*/ 32084 h 641684"/>
              <a:gd name="connsiteX4" fmla="*/ 112959 w 707982"/>
              <a:gd name="connsiteY4" fmla="*/ 64168 h 641684"/>
              <a:gd name="connsiteX5" fmla="*/ 96917 w 707982"/>
              <a:gd name="connsiteY5" fmla="*/ 80211 h 641684"/>
              <a:gd name="connsiteX6" fmla="*/ 80875 w 707982"/>
              <a:gd name="connsiteY6" fmla="*/ 144379 h 641684"/>
              <a:gd name="connsiteX7" fmla="*/ 64833 w 707982"/>
              <a:gd name="connsiteY7" fmla="*/ 192505 h 641684"/>
              <a:gd name="connsiteX8" fmla="*/ 32749 w 707982"/>
              <a:gd name="connsiteY8" fmla="*/ 240632 h 641684"/>
              <a:gd name="connsiteX9" fmla="*/ 16707 w 707982"/>
              <a:gd name="connsiteY9" fmla="*/ 272716 h 641684"/>
              <a:gd name="connsiteX10" fmla="*/ 16707 w 707982"/>
              <a:gd name="connsiteY10" fmla="*/ 561474 h 641684"/>
              <a:gd name="connsiteX11" fmla="*/ 32749 w 707982"/>
              <a:gd name="connsiteY11" fmla="*/ 593558 h 641684"/>
              <a:gd name="connsiteX12" fmla="*/ 161086 w 707982"/>
              <a:gd name="connsiteY12" fmla="*/ 641684 h 641684"/>
              <a:gd name="connsiteX13" fmla="*/ 257338 w 707982"/>
              <a:gd name="connsiteY13" fmla="*/ 625642 h 641684"/>
              <a:gd name="connsiteX14" fmla="*/ 289423 w 707982"/>
              <a:gd name="connsiteY14" fmla="*/ 609600 h 641684"/>
              <a:gd name="connsiteX15" fmla="*/ 385675 w 707982"/>
              <a:gd name="connsiteY15" fmla="*/ 593558 h 641684"/>
              <a:gd name="connsiteX16" fmla="*/ 514012 w 707982"/>
              <a:gd name="connsiteY16" fmla="*/ 529389 h 641684"/>
              <a:gd name="connsiteX17" fmla="*/ 546096 w 707982"/>
              <a:gd name="connsiteY17" fmla="*/ 513347 h 641684"/>
              <a:gd name="connsiteX18" fmla="*/ 578180 w 707982"/>
              <a:gd name="connsiteY18" fmla="*/ 497305 h 641684"/>
              <a:gd name="connsiteX19" fmla="*/ 594223 w 707982"/>
              <a:gd name="connsiteY19" fmla="*/ 481263 h 641684"/>
              <a:gd name="connsiteX20" fmla="*/ 642349 w 707982"/>
              <a:gd name="connsiteY20" fmla="*/ 433137 h 641684"/>
              <a:gd name="connsiteX21" fmla="*/ 674433 w 707982"/>
              <a:gd name="connsiteY21" fmla="*/ 352926 h 641684"/>
              <a:gd name="connsiteX22" fmla="*/ 690475 w 707982"/>
              <a:gd name="connsiteY22" fmla="*/ 176463 h 641684"/>
              <a:gd name="connsiteX23" fmla="*/ 706517 w 707982"/>
              <a:gd name="connsiteY23" fmla="*/ 144379 h 641684"/>
              <a:gd name="connsiteX24" fmla="*/ 642349 w 707982"/>
              <a:gd name="connsiteY24" fmla="*/ 112295 h 641684"/>
              <a:gd name="connsiteX25" fmla="*/ 514012 w 707982"/>
              <a:gd name="connsiteY25" fmla="*/ 48126 h 641684"/>
              <a:gd name="connsiteX26" fmla="*/ 305465 w 707982"/>
              <a:gd name="connsiteY26" fmla="*/ 80211 h 641684"/>
              <a:gd name="connsiteX27" fmla="*/ 241296 w 707982"/>
              <a:gd name="connsiteY27" fmla="*/ 64168 h 641684"/>
              <a:gd name="connsiteX28" fmla="*/ 257338 w 707982"/>
              <a:gd name="connsiteY28" fmla="*/ 64168 h 64168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707982" h="641684">
                <a:moveTo>
                  <a:pt x="401717" y="48126"/>
                </a:moveTo>
                <a:cubicBezTo>
                  <a:pt x="385675" y="37431"/>
                  <a:pt x="370124" y="25962"/>
                  <a:pt x="353591" y="16042"/>
                </a:cubicBezTo>
                <a:cubicBezTo>
                  <a:pt x="343338" y="9890"/>
                  <a:pt x="333464" y="0"/>
                  <a:pt x="321507" y="0"/>
                </a:cubicBezTo>
                <a:cubicBezTo>
                  <a:pt x="246400" y="0"/>
                  <a:pt x="196584" y="15189"/>
                  <a:pt x="129001" y="32084"/>
                </a:cubicBezTo>
                <a:cubicBezTo>
                  <a:pt x="123654" y="42779"/>
                  <a:pt x="119591" y="54219"/>
                  <a:pt x="112959" y="64168"/>
                </a:cubicBezTo>
                <a:cubicBezTo>
                  <a:pt x="108764" y="70460"/>
                  <a:pt x="99726" y="73189"/>
                  <a:pt x="96917" y="80211"/>
                </a:cubicBezTo>
                <a:cubicBezTo>
                  <a:pt x="88729" y="100682"/>
                  <a:pt x="86932" y="123180"/>
                  <a:pt x="80875" y="144379"/>
                </a:cubicBezTo>
                <a:cubicBezTo>
                  <a:pt x="76230" y="160638"/>
                  <a:pt x="71113" y="176805"/>
                  <a:pt x="64833" y="192505"/>
                </a:cubicBezTo>
                <a:cubicBezTo>
                  <a:pt x="35756" y="265197"/>
                  <a:pt x="63351" y="194728"/>
                  <a:pt x="32749" y="240632"/>
                </a:cubicBezTo>
                <a:cubicBezTo>
                  <a:pt x="26117" y="250581"/>
                  <a:pt x="22054" y="262021"/>
                  <a:pt x="16707" y="272716"/>
                </a:cubicBezTo>
                <a:cubicBezTo>
                  <a:pt x="-1340" y="417097"/>
                  <a:pt x="-9434" y="404628"/>
                  <a:pt x="16707" y="561474"/>
                </a:cubicBezTo>
                <a:cubicBezTo>
                  <a:pt x="18673" y="573268"/>
                  <a:pt x="23412" y="586089"/>
                  <a:pt x="32749" y="593558"/>
                </a:cubicBezTo>
                <a:cubicBezTo>
                  <a:pt x="70880" y="624063"/>
                  <a:pt x="115903" y="630389"/>
                  <a:pt x="161086" y="641684"/>
                </a:cubicBezTo>
                <a:cubicBezTo>
                  <a:pt x="193170" y="636337"/>
                  <a:pt x="225783" y="633531"/>
                  <a:pt x="257338" y="625642"/>
                </a:cubicBezTo>
                <a:cubicBezTo>
                  <a:pt x="268938" y="622742"/>
                  <a:pt x="277823" y="612500"/>
                  <a:pt x="289423" y="609600"/>
                </a:cubicBezTo>
                <a:cubicBezTo>
                  <a:pt x="320978" y="601711"/>
                  <a:pt x="353591" y="598905"/>
                  <a:pt x="385675" y="593558"/>
                </a:cubicBezTo>
                <a:lnTo>
                  <a:pt x="514012" y="529389"/>
                </a:lnTo>
                <a:lnTo>
                  <a:pt x="546096" y="513347"/>
                </a:lnTo>
                <a:cubicBezTo>
                  <a:pt x="556791" y="508000"/>
                  <a:pt x="569725" y="505760"/>
                  <a:pt x="578180" y="497305"/>
                </a:cubicBezTo>
                <a:lnTo>
                  <a:pt x="594223" y="481263"/>
                </a:lnTo>
                <a:cubicBezTo>
                  <a:pt x="637002" y="395706"/>
                  <a:pt x="578181" y="497305"/>
                  <a:pt x="642349" y="433137"/>
                </a:cubicBezTo>
                <a:cubicBezTo>
                  <a:pt x="654152" y="421334"/>
                  <a:pt x="671301" y="362323"/>
                  <a:pt x="674433" y="352926"/>
                </a:cubicBezTo>
                <a:cubicBezTo>
                  <a:pt x="679780" y="294105"/>
                  <a:pt x="681494" y="234840"/>
                  <a:pt x="690475" y="176463"/>
                </a:cubicBezTo>
                <a:cubicBezTo>
                  <a:pt x="692293" y="164645"/>
                  <a:pt x="713691" y="153945"/>
                  <a:pt x="706517" y="144379"/>
                </a:cubicBezTo>
                <a:cubicBezTo>
                  <a:pt x="692169" y="125248"/>
                  <a:pt x="659259" y="129205"/>
                  <a:pt x="642349" y="112295"/>
                </a:cubicBezTo>
                <a:cubicBezTo>
                  <a:pt x="574943" y="44887"/>
                  <a:pt x="616469" y="68617"/>
                  <a:pt x="514012" y="48126"/>
                </a:cubicBezTo>
                <a:cubicBezTo>
                  <a:pt x="452956" y="60337"/>
                  <a:pt x="363730" y="80211"/>
                  <a:pt x="305465" y="80211"/>
                </a:cubicBezTo>
                <a:cubicBezTo>
                  <a:pt x="283417" y="80211"/>
                  <a:pt x="262213" y="71140"/>
                  <a:pt x="241296" y="64168"/>
                </a:cubicBezTo>
                <a:cubicBezTo>
                  <a:pt x="236223" y="62477"/>
                  <a:pt x="251991" y="64168"/>
                  <a:pt x="257338" y="64168"/>
                </a:cubicBezTo>
              </a:path>
            </a:pathLst>
          </a:cu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Freeform 3"/>
          <p:cNvSpPr/>
          <p:nvPr/>
        </p:nvSpPr>
        <p:spPr>
          <a:xfrm>
            <a:off x="1708484" y="1074821"/>
            <a:ext cx="481263" cy="465221"/>
          </a:xfrm>
          <a:custGeom>
            <a:avLst/>
            <a:gdLst>
              <a:gd name="connsiteX0" fmla="*/ 465221 w 481263"/>
              <a:gd name="connsiteY0" fmla="*/ 48126 h 465221"/>
              <a:gd name="connsiteX1" fmla="*/ 417095 w 481263"/>
              <a:gd name="connsiteY1" fmla="*/ 32084 h 465221"/>
              <a:gd name="connsiteX2" fmla="*/ 304800 w 481263"/>
              <a:gd name="connsiteY2" fmla="*/ 0 h 465221"/>
              <a:gd name="connsiteX3" fmla="*/ 272716 w 481263"/>
              <a:gd name="connsiteY3" fmla="*/ 16042 h 465221"/>
              <a:gd name="connsiteX4" fmla="*/ 128337 w 481263"/>
              <a:gd name="connsiteY4" fmla="*/ 32084 h 465221"/>
              <a:gd name="connsiteX5" fmla="*/ 80211 w 481263"/>
              <a:gd name="connsiteY5" fmla="*/ 80211 h 465221"/>
              <a:gd name="connsiteX6" fmla="*/ 64169 w 481263"/>
              <a:gd name="connsiteY6" fmla="*/ 128337 h 465221"/>
              <a:gd name="connsiteX7" fmla="*/ 32084 w 481263"/>
              <a:gd name="connsiteY7" fmla="*/ 208547 h 465221"/>
              <a:gd name="connsiteX8" fmla="*/ 0 w 481263"/>
              <a:gd name="connsiteY8" fmla="*/ 304800 h 465221"/>
              <a:gd name="connsiteX9" fmla="*/ 16042 w 481263"/>
              <a:gd name="connsiteY9" fmla="*/ 336884 h 465221"/>
              <a:gd name="connsiteX10" fmla="*/ 48127 w 481263"/>
              <a:gd name="connsiteY10" fmla="*/ 449179 h 465221"/>
              <a:gd name="connsiteX11" fmla="*/ 80211 w 481263"/>
              <a:gd name="connsiteY11" fmla="*/ 465221 h 465221"/>
              <a:gd name="connsiteX12" fmla="*/ 144379 w 481263"/>
              <a:gd name="connsiteY12" fmla="*/ 449179 h 465221"/>
              <a:gd name="connsiteX13" fmla="*/ 208548 w 481263"/>
              <a:gd name="connsiteY13" fmla="*/ 417095 h 465221"/>
              <a:gd name="connsiteX14" fmla="*/ 240632 w 481263"/>
              <a:gd name="connsiteY14" fmla="*/ 401053 h 465221"/>
              <a:gd name="connsiteX15" fmla="*/ 288758 w 481263"/>
              <a:gd name="connsiteY15" fmla="*/ 385011 h 465221"/>
              <a:gd name="connsiteX16" fmla="*/ 401053 w 481263"/>
              <a:gd name="connsiteY16" fmla="*/ 352926 h 465221"/>
              <a:gd name="connsiteX17" fmla="*/ 433137 w 481263"/>
              <a:gd name="connsiteY17" fmla="*/ 336884 h 465221"/>
              <a:gd name="connsiteX18" fmla="*/ 465221 w 481263"/>
              <a:gd name="connsiteY18" fmla="*/ 272716 h 465221"/>
              <a:gd name="connsiteX19" fmla="*/ 481263 w 481263"/>
              <a:gd name="connsiteY19" fmla="*/ 240632 h 465221"/>
              <a:gd name="connsiteX20" fmla="*/ 465221 w 481263"/>
              <a:gd name="connsiteY20" fmla="*/ 112295 h 465221"/>
              <a:gd name="connsiteX21" fmla="*/ 433137 w 481263"/>
              <a:gd name="connsiteY21" fmla="*/ 64168 h 465221"/>
              <a:gd name="connsiteX22" fmla="*/ 401053 w 481263"/>
              <a:gd name="connsiteY22" fmla="*/ 48126 h 46522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</a:cxnLst>
            <a:rect l="l" t="t" r="r" b="b"/>
            <a:pathLst>
              <a:path w="481263" h="465221">
                <a:moveTo>
                  <a:pt x="465221" y="48126"/>
                </a:moveTo>
                <a:cubicBezTo>
                  <a:pt x="449179" y="42779"/>
                  <a:pt x="433500" y="36185"/>
                  <a:pt x="417095" y="32084"/>
                </a:cubicBezTo>
                <a:cubicBezTo>
                  <a:pt x="306772" y="4503"/>
                  <a:pt x="369335" y="32268"/>
                  <a:pt x="304800" y="0"/>
                </a:cubicBezTo>
                <a:cubicBezTo>
                  <a:pt x="294105" y="5347"/>
                  <a:pt x="284480" y="13903"/>
                  <a:pt x="272716" y="16042"/>
                </a:cubicBezTo>
                <a:cubicBezTo>
                  <a:pt x="225075" y="24704"/>
                  <a:pt x="174275" y="16771"/>
                  <a:pt x="128337" y="32084"/>
                </a:cubicBezTo>
                <a:cubicBezTo>
                  <a:pt x="106814" y="39258"/>
                  <a:pt x="80211" y="80211"/>
                  <a:pt x="80211" y="80211"/>
                </a:cubicBezTo>
                <a:cubicBezTo>
                  <a:pt x="74864" y="96253"/>
                  <a:pt x="68814" y="112078"/>
                  <a:pt x="64169" y="128337"/>
                </a:cubicBezTo>
                <a:cubicBezTo>
                  <a:pt x="42718" y="203417"/>
                  <a:pt x="64944" y="175689"/>
                  <a:pt x="32084" y="208547"/>
                </a:cubicBezTo>
                <a:cubicBezTo>
                  <a:pt x="16455" y="239805"/>
                  <a:pt x="0" y="266917"/>
                  <a:pt x="0" y="304800"/>
                </a:cubicBezTo>
                <a:cubicBezTo>
                  <a:pt x="0" y="316757"/>
                  <a:pt x="10695" y="326189"/>
                  <a:pt x="16042" y="336884"/>
                </a:cubicBezTo>
                <a:cubicBezTo>
                  <a:pt x="17432" y="342444"/>
                  <a:pt x="39494" y="437669"/>
                  <a:pt x="48127" y="449179"/>
                </a:cubicBezTo>
                <a:cubicBezTo>
                  <a:pt x="55301" y="458745"/>
                  <a:pt x="69516" y="459874"/>
                  <a:pt x="80211" y="465221"/>
                </a:cubicBezTo>
                <a:cubicBezTo>
                  <a:pt x="101600" y="459874"/>
                  <a:pt x="123735" y="456920"/>
                  <a:pt x="144379" y="449179"/>
                </a:cubicBezTo>
                <a:cubicBezTo>
                  <a:pt x="166771" y="440782"/>
                  <a:pt x="187158" y="427790"/>
                  <a:pt x="208548" y="417095"/>
                </a:cubicBezTo>
                <a:cubicBezTo>
                  <a:pt x="219243" y="411748"/>
                  <a:pt x="229289" y="404834"/>
                  <a:pt x="240632" y="401053"/>
                </a:cubicBezTo>
                <a:cubicBezTo>
                  <a:pt x="256674" y="395706"/>
                  <a:pt x="272499" y="389657"/>
                  <a:pt x="288758" y="385011"/>
                </a:cubicBezTo>
                <a:cubicBezTo>
                  <a:pt x="341993" y="369801"/>
                  <a:pt x="352978" y="372156"/>
                  <a:pt x="401053" y="352926"/>
                </a:cubicBezTo>
                <a:cubicBezTo>
                  <a:pt x="412155" y="348485"/>
                  <a:pt x="422442" y="342231"/>
                  <a:pt x="433137" y="336884"/>
                </a:cubicBezTo>
                <a:lnTo>
                  <a:pt x="465221" y="272716"/>
                </a:lnTo>
                <a:lnTo>
                  <a:pt x="481263" y="240632"/>
                </a:lnTo>
                <a:cubicBezTo>
                  <a:pt x="475916" y="197853"/>
                  <a:pt x="473676" y="154570"/>
                  <a:pt x="465221" y="112295"/>
                </a:cubicBezTo>
                <a:cubicBezTo>
                  <a:pt x="462224" y="97311"/>
                  <a:pt x="447244" y="73573"/>
                  <a:pt x="433137" y="64168"/>
                </a:cubicBezTo>
                <a:cubicBezTo>
                  <a:pt x="423188" y="57535"/>
                  <a:pt x="401053" y="48126"/>
                  <a:pt x="401053" y="48126"/>
                </a:cubicBezTo>
              </a:path>
            </a:pathLst>
          </a:cu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18</Words>
  <Application>Microsoft Office PowerPoint</Application>
  <PresentationFormat>On-screen Show (4:3)</PresentationFormat>
  <Paragraphs>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olumbia University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orjabad</dc:creator>
  <cp:lastModifiedBy>Columbia University</cp:lastModifiedBy>
  <cp:revision>2</cp:revision>
  <dcterms:created xsi:type="dcterms:W3CDTF">2011-05-09T17:56:37Z</dcterms:created>
  <dcterms:modified xsi:type="dcterms:W3CDTF">2011-05-10T00:25:05Z</dcterms:modified>
</cp:coreProperties>
</file>